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30" autoAdjust="0"/>
    <p:restoredTop sz="93666" autoAdjust="0"/>
  </p:normalViewPr>
  <p:slideViewPr>
    <p:cSldViewPr snapToGrid="0">
      <p:cViewPr>
        <p:scale>
          <a:sx n="150" d="100"/>
          <a:sy n="150" d="100"/>
        </p:scale>
        <p:origin x="3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0264B6-46A5-4885-B5EE-04B05130A9E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FE8B58-4F3B-4A7B-B892-A499030AB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11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FE8B58-4F3B-4A7B-B892-A499030AB8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916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123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307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811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920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284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093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276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008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128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263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922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D18F8-467C-43AA-B0CF-AB159F661F74}" type="datetimeFigureOut">
              <a:rPr lang="en-US" smtClean="0"/>
              <a:t>4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4C17F-1B4E-4BE3-8995-9C4C862F07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935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21DC4B3-0CF0-588B-E57D-BF14F65018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5241" y="520096"/>
            <a:ext cx="6288216" cy="41870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909BB4-B402-F7CE-EE6E-29C7AA9ACF03}"/>
              </a:ext>
            </a:extLst>
          </p:cNvPr>
          <p:cNvSpPr txBox="1"/>
          <p:nvPr/>
        </p:nvSpPr>
        <p:spPr>
          <a:xfrm>
            <a:off x="755650" y="4985461"/>
            <a:ext cx="569719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iremia, viral shedding and antibody levels. (A-D) Viral loads in serum, saliva, nasal and rectal swabs are shown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40-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over the first 14 days of the study. (E) PRRSV-specific antibody levels are shown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S/P ratios over the first 14 days. 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ignificant statistical difference is indicated by * (p &lt; 0.05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93F2A0-3AE1-8DAE-F3E3-0CD66ABD0AD6}"/>
              </a:ext>
            </a:extLst>
          </p:cNvPr>
          <p:cNvSpPr txBox="1"/>
          <p:nvPr/>
        </p:nvSpPr>
        <p:spPr>
          <a:xfrm>
            <a:off x="624272" y="590820"/>
            <a:ext cx="423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28876FA-55B1-A4BA-831C-DF9B338E9913}"/>
              </a:ext>
            </a:extLst>
          </p:cNvPr>
          <p:cNvSpPr txBox="1"/>
          <p:nvPr/>
        </p:nvSpPr>
        <p:spPr>
          <a:xfrm>
            <a:off x="2614549" y="590820"/>
            <a:ext cx="423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227F4B-B2EF-EDCD-8AA7-198863A7908F}"/>
              </a:ext>
            </a:extLst>
          </p:cNvPr>
          <p:cNvSpPr txBox="1"/>
          <p:nvPr/>
        </p:nvSpPr>
        <p:spPr>
          <a:xfrm>
            <a:off x="624272" y="2598890"/>
            <a:ext cx="423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18030D4-B8F3-11B6-524D-DAC34A3CF60F}"/>
              </a:ext>
            </a:extLst>
          </p:cNvPr>
          <p:cNvSpPr txBox="1"/>
          <p:nvPr/>
        </p:nvSpPr>
        <p:spPr>
          <a:xfrm>
            <a:off x="2614549" y="2594499"/>
            <a:ext cx="423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E32C683-9D12-1283-7FA8-511F61169CDF}"/>
              </a:ext>
            </a:extLst>
          </p:cNvPr>
          <p:cNvSpPr txBox="1"/>
          <p:nvPr/>
        </p:nvSpPr>
        <p:spPr>
          <a:xfrm>
            <a:off x="4680461" y="2598890"/>
            <a:ext cx="423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154B2B7C-12FB-C0B4-26DE-7234FB0A10C3}"/>
              </a:ext>
            </a:extLst>
          </p:cNvPr>
          <p:cNvGrpSpPr/>
          <p:nvPr/>
        </p:nvGrpSpPr>
        <p:grpSpPr>
          <a:xfrm>
            <a:off x="5507935" y="3102238"/>
            <a:ext cx="647798" cy="310070"/>
            <a:chOff x="6110287" y="1740409"/>
            <a:chExt cx="528638" cy="310070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8E06297C-9CF1-B237-D197-A9F3F64B08F6}"/>
                </a:ext>
              </a:extLst>
            </p:cNvPr>
            <p:cNvGrpSpPr/>
            <p:nvPr/>
          </p:nvGrpSpPr>
          <p:grpSpPr>
            <a:xfrm>
              <a:off x="6110287" y="1740409"/>
              <a:ext cx="528638" cy="310070"/>
              <a:chOff x="6110287" y="1740409"/>
              <a:chExt cx="528638" cy="310070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0F5B1F8-E8D8-DBED-73D6-572FD075FE99}"/>
                  </a:ext>
                </a:extLst>
              </p:cNvPr>
              <p:cNvSpPr txBox="1"/>
              <p:nvPr/>
            </p:nvSpPr>
            <p:spPr>
              <a:xfrm>
                <a:off x="6367462" y="1850424"/>
                <a:ext cx="2714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FF23FC7B-98CC-5379-98A4-E16CABA888C3}"/>
                  </a:ext>
                </a:extLst>
              </p:cNvPr>
              <p:cNvCxnSpPr/>
              <p:nvPr/>
            </p:nvCxnSpPr>
            <p:spPr>
              <a:xfrm>
                <a:off x="6367463" y="1976419"/>
                <a:ext cx="271462" cy="0"/>
              </a:xfrm>
              <a:prstGeom prst="line">
                <a:avLst/>
              </a:prstGeom>
              <a:ln w="952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FF2E45BB-DD0C-1C12-2BAF-013F9E297724}"/>
                  </a:ext>
                </a:extLst>
              </p:cNvPr>
              <p:cNvSpPr txBox="1"/>
              <p:nvPr/>
            </p:nvSpPr>
            <p:spPr>
              <a:xfrm>
                <a:off x="6110287" y="1740409"/>
                <a:ext cx="5286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14531FBE-9240-E1D8-2168-FFE947DAC323}"/>
                </a:ext>
              </a:extLst>
            </p:cNvPr>
            <p:cNvCxnSpPr>
              <a:cxnSpLocks/>
            </p:cNvCxnSpPr>
            <p:nvPr/>
          </p:nvCxnSpPr>
          <p:spPr>
            <a:xfrm>
              <a:off x="6110288" y="1862117"/>
              <a:ext cx="52863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14F6D8B5-D066-F8E7-ACFC-BD8FE7FA6BDB}"/>
              </a:ext>
            </a:extLst>
          </p:cNvPr>
          <p:cNvGrpSpPr/>
          <p:nvPr/>
        </p:nvGrpSpPr>
        <p:grpSpPr>
          <a:xfrm>
            <a:off x="1557471" y="888070"/>
            <a:ext cx="647802" cy="310070"/>
            <a:chOff x="6110287" y="1740409"/>
            <a:chExt cx="528638" cy="310070"/>
          </a:xfrm>
        </p:grpSpPr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4C8E2CF8-9B94-BFE1-08E0-D04FC0545290}"/>
                </a:ext>
              </a:extLst>
            </p:cNvPr>
            <p:cNvGrpSpPr/>
            <p:nvPr/>
          </p:nvGrpSpPr>
          <p:grpSpPr>
            <a:xfrm>
              <a:off x="6110287" y="1740409"/>
              <a:ext cx="528638" cy="310070"/>
              <a:chOff x="6110287" y="1740409"/>
              <a:chExt cx="528638" cy="310070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AD07D15-A92F-7F26-5D69-F5226FE5A223}"/>
                  </a:ext>
                </a:extLst>
              </p:cNvPr>
              <p:cNvSpPr txBox="1"/>
              <p:nvPr/>
            </p:nvSpPr>
            <p:spPr>
              <a:xfrm>
                <a:off x="6367462" y="1850424"/>
                <a:ext cx="2714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B95ED092-1251-DFB8-0E93-CA48D74187EB}"/>
                  </a:ext>
                </a:extLst>
              </p:cNvPr>
              <p:cNvCxnSpPr/>
              <p:nvPr/>
            </p:nvCxnSpPr>
            <p:spPr>
              <a:xfrm>
                <a:off x="6367463" y="1976419"/>
                <a:ext cx="271462" cy="0"/>
              </a:xfrm>
              <a:prstGeom prst="line">
                <a:avLst/>
              </a:prstGeom>
              <a:ln w="952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7942E374-8857-18D6-7F4C-69E38BC3236E}"/>
                  </a:ext>
                </a:extLst>
              </p:cNvPr>
              <p:cNvSpPr txBox="1"/>
              <p:nvPr/>
            </p:nvSpPr>
            <p:spPr>
              <a:xfrm>
                <a:off x="6110287" y="1740409"/>
                <a:ext cx="5286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2E14C043-FC88-FCC4-04FD-087772678758}"/>
                </a:ext>
              </a:extLst>
            </p:cNvPr>
            <p:cNvCxnSpPr>
              <a:cxnSpLocks/>
            </p:cNvCxnSpPr>
            <p:nvPr/>
          </p:nvCxnSpPr>
          <p:spPr>
            <a:xfrm>
              <a:off x="6110288" y="1862117"/>
              <a:ext cx="52863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602E6DA-0CED-A804-3EBF-C958E7EF6F3C}"/>
              </a:ext>
            </a:extLst>
          </p:cNvPr>
          <p:cNvGrpSpPr/>
          <p:nvPr/>
        </p:nvGrpSpPr>
        <p:grpSpPr>
          <a:xfrm>
            <a:off x="3527080" y="1124203"/>
            <a:ext cx="647802" cy="310070"/>
            <a:chOff x="6110287" y="1740409"/>
            <a:chExt cx="528638" cy="310070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FC035CE3-4F66-A4AE-8967-FC400A6B8497}"/>
                </a:ext>
              </a:extLst>
            </p:cNvPr>
            <p:cNvGrpSpPr/>
            <p:nvPr/>
          </p:nvGrpSpPr>
          <p:grpSpPr>
            <a:xfrm>
              <a:off x="6110287" y="1740409"/>
              <a:ext cx="528638" cy="310070"/>
              <a:chOff x="6110287" y="1740409"/>
              <a:chExt cx="528638" cy="310070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B5A382C-C93C-922D-7589-EA8686F499FA}"/>
                  </a:ext>
                </a:extLst>
              </p:cNvPr>
              <p:cNvSpPr txBox="1"/>
              <p:nvPr/>
            </p:nvSpPr>
            <p:spPr>
              <a:xfrm>
                <a:off x="6367462" y="1850424"/>
                <a:ext cx="2714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9F940B35-FFED-C807-02D7-FC8A8243D240}"/>
                  </a:ext>
                </a:extLst>
              </p:cNvPr>
              <p:cNvCxnSpPr/>
              <p:nvPr/>
            </p:nvCxnSpPr>
            <p:spPr>
              <a:xfrm>
                <a:off x="6367463" y="1976419"/>
                <a:ext cx="271462" cy="0"/>
              </a:xfrm>
              <a:prstGeom prst="line">
                <a:avLst/>
              </a:prstGeom>
              <a:ln w="952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B1552913-8292-5D8B-6538-98551D5EB6C1}"/>
                  </a:ext>
                </a:extLst>
              </p:cNvPr>
              <p:cNvSpPr txBox="1"/>
              <p:nvPr/>
            </p:nvSpPr>
            <p:spPr>
              <a:xfrm>
                <a:off x="6110287" y="1740409"/>
                <a:ext cx="5286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0C74F613-B6EE-F664-FAB3-340D7E89F95B}"/>
                </a:ext>
              </a:extLst>
            </p:cNvPr>
            <p:cNvCxnSpPr>
              <a:cxnSpLocks/>
            </p:cNvCxnSpPr>
            <p:nvPr/>
          </p:nvCxnSpPr>
          <p:spPr>
            <a:xfrm>
              <a:off x="6110288" y="1862117"/>
              <a:ext cx="52863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03108D14-BCD1-6235-C771-E6F8E635EE9C}"/>
              </a:ext>
            </a:extLst>
          </p:cNvPr>
          <p:cNvGrpSpPr/>
          <p:nvPr/>
        </p:nvGrpSpPr>
        <p:grpSpPr>
          <a:xfrm>
            <a:off x="3525969" y="3407602"/>
            <a:ext cx="647800" cy="310070"/>
            <a:chOff x="6110287" y="1740409"/>
            <a:chExt cx="528638" cy="310070"/>
          </a:xfrm>
        </p:grpSpPr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62BB7074-B6F0-A70F-4771-A026AA1022BF}"/>
                </a:ext>
              </a:extLst>
            </p:cNvPr>
            <p:cNvGrpSpPr/>
            <p:nvPr/>
          </p:nvGrpSpPr>
          <p:grpSpPr>
            <a:xfrm>
              <a:off x="6110287" y="1740409"/>
              <a:ext cx="528638" cy="310070"/>
              <a:chOff x="6110287" y="1740409"/>
              <a:chExt cx="528638" cy="310070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E472391-7E50-20E7-F8DF-B41D6F4A0E83}"/>
                  </a:ext>
                </a:extLst>
              </p:cNvPr>
              <p:cNvSpPr txBox="1"/>
              <p:nvPr/>
            </p:nvSpPr>
            <p:spPr>
              <a:xfrm>
                <a:off x="6367462" y="1850424"/>
                <a:ext cx="2714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61A3AA6A-F19B-BFF6-4611-AA2DACA0D9DC}"/>
                  </a:ext>
                </a:extLst>
              </p:cNvPr>
              <p:cNvCxnSpPr/>
              <p:nvPr/>
            </p:nvCxnSpPr>
            <p:spPr>
              <a:xfrm>
                <a:off x="6367463" y="1976419"/>
                <a:ext cx="271462" cy="0"/>
              </a:xfrm>
              <a:prstGeom prst="line">
                <a:avLst/>
              </a:prstGeom>
              <a:ln w="952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0C66206F-6791-61FB-3EF2-314C5D45B2C9}"/>
                  </a:ext>
                </a:extLst>
              </p:cNvPr>
              <p:cNvSpPr txBox="1"/>
              <p:nvPr/>
            </p:nvSpPr>
            <p:spPr>
              <a:xfrm>
                <a:off x="6110287" y="1740409"/>
                <a:ext cx="5286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E71B4340-6EB3-C960-6B5A-ABF22A10E5BA}"/>
                </a:ext>
              </a:extLst>
            </p:cNvPr>
            <p:cNvCxnSpPr>
              <a:cxnSpLocks/>
            </p:cNvCxnSpPr>
            <p:nvPr/>
          </p:nvCxnSpPr>
          <p:spPr>
            <a:xfrm>
              <a:off x="6110288" y="1862117"/>
              <a:ext cx="52863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C5BBC3E8-AF63-68F3-5025-B4B55D93A97B}"/>
              </a:ext>
            </a:extLst>
          </p:cNvPr>
          <p:cNvGrpSpPr/>
          <p:nvPr/>
        </p:nvGrpSpPr>
        <p:grpSpPr>
          <a:xfrm>
            <a:off x="1564614" y="3272051"/>
            <a:ext cx="647801" cy="400307"/>
            <a:chOff x="1976149" y="2734428"/>
            <a:chExt cx="537783" cy="400307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626706F-7D74-C4E8-B0FF-526CD90DB678}"/>
                </a:ext>
              </a:extLst>
            </p:cNvPr>
            <p:cNvSpPr txBox="1"/>
            <p:nvPr/>
          </p:nvSpPr>
          <p:spPr>
            <a:xfrm>
              <a:off x="2242470" y="2843135"/>
              <a:ext cx="2714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2278B542-EF00-0259-5F1F-D58CBC294A9A}"/>
                </a:ext>
              </a:extLst>
            </p:cNvPr>
            <p:cNvCxnSpPr>
              <a:cxnSpLocks/>
            </p:cNvCxnSpPr>
            <p:nvPr/>
          </p:nvCxnSpPr>
          <p:spPr>
            <a:xfrm>
              <a:off x="1983961" y="3054545"/>
              <a:ext cx="264319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27F17428-9E9F-8110-780F-D81CB466C183}"/>
                </a:ext>
              </a:extLst>
            </p:cNvPr>
            <p:cNvGrpSpPr/>
            <p:nvPr/>
          </p:nvGrpSpPr>
          <p:grpSpPr>
            <a:xfrm>
              <a:off x="1976149" y="2734428"/>
              <a:ext cx="535781" cy="400307"/>
              <a:chOff x="3359403" y="1970549"/>
              <a:chExt cx="535781" cy="400307"/>
            </a:xfrm>
          </p:grpSpPr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B117FD18-E849-7975-263A-2DE02015FD43}"/>
                  </a:ext>
                </a:extLst>
              </p:cNvPr>
              <p:cNvGrpSpPr/>
              <p:nvPr/>
            </p:nvGrpSpPr>
            <p:grpSpPr>
              <a:xfrm>
                <a:off x="3359403" y="1970549"/>
                <a:ext cx="535781" cy="400307"/>
                <a:chOff x="6099428" y="1665382"/>
                <a:chExt cx="535781" cy="400307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7CC51D41-F0F7-8721-AFFF-720A65B6EA75}"/>
                    </a:ext>
                  </a:extLst>
                </p:cNvPr>
                <p:cNvSpPr txBox="1"/>
                <p:nvPr/>
              </p:nvSpPr>
              <p:spPr>
                <a:xfrm>
                  <a:off x="6103143" y="1865634"/>
                  <a:ext cx="2714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205CC849-065B-A6D6-3469-36CD2284FC8A}"/>
                    </a:ext>
                  </a:extLst>
                </p:cNvPr>
                <p:cNvSpPr txBox="1"/>
                <p:nvPr/>
              </p:nvSpPr>
              <p:spPr>
                <a:xfrm>
                  <a:off x="6099428" y="1665382"/>
                  <a:ext cx="5286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</a:p>
              </p:txBody>
            </p: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0E110A32-1908-7545-E5E1-FE34E1B31830}"/>
                    </a:ext>
                  </a:extLst>
                </p:cNvPr>
                <p:cNvCxnSpPr/>
                <p:nvPr/>
              </p:nvCxnSpPr>
              <p:spPr>
                <a:xfrm>
                  <a:off x="6363747" y="1892143"/>
                  <a:ext cx="271462" cy="0"/>
                </a:xfrm>
                <a:prstGeom prst="line">
                  <a:avLst/>
                </a:prstGeom>
                <a:ln w="9525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E6B436D7-BCB4-7B56-8B2B-DCB80D9E06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64165" y="2090597"/>
                <a:ext cx="528637" cy="0"/>
              </a:xfrm>
              <a:prstGeom prst="line">
                <a:avLst/>
              </a:prstGeom>
              <a:ln w="952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097445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80</TotalTime>
  <Words>101</Words>
  <Application>Microsoft Office PowerPoint</Application>
  <PresentationFormat>A4 Paper (210x297 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 Stoian</dc:creator>
  <cp:lastModifiedBy>Ana Stoian</cp:lastModifiedBy>
  <cp:revision>488</cp:revision>
  <dcterms:created xsi:type="dcterms:W3CDTF">2024-03-04T16:12:29Z</dcterms:created>
  <dcterms:modified xsi:type="dcterms:W3CDTF">2025-04-16T11:04:47Z</dcterms:modified>
</cp:coreProperties>
</file>